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8"/>
  </p:notesMasterIdLst>
  <p:handoutMasterIdLst>
    <p:handoutMasterId r:id="rId9"/>
  </p:handoutMasterIdLst>
  <p:sldIdLst>
    <p:sldId id="471" r:id="rId2"/>
    <p:sldId id="457" r:id="rId3"/>
    <p:sldId id="475" r:id="rId4"/>
    <p:sldId id="472" r:id="rId5"/>
    <p:sldId id="473" r:id="rId6"/>
    <p:sldId id="474" r:id="rId7"/>
  </p:sldIdLst>
  <p:sldSz cx="6858000" cy="9902825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05" userDrawn="1">
          <p15:clr>
            <a:srgbClr val="A4A3A4"/>
          </p15:clr>
        </p15:guide>
        <p15:guide id="2" pos="2038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0C10B4"/>
    <a:srgbClr val="F2B77C"/>
    <a:srgbClr val="F1E4BA"/>
    <a:srgbClr val="FAFAFA"/>
    <a:srgbClr val="84AF9B"/>
    <a:srgbClr val="DCDCDC"/>
    <a:srgbClr val="F0F0F0"/>
    <a:srgbClr val="E6E6E6"/>
    <a:srgbClr val="C8C8C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985" autoAdjust="0"/>
    <p:restoredTop sz="94408" autoAdjust="0"/>
  </p:normalViewPr>
  <p:slideViewPr>
    <p:cSldViewPr snapToGrid="0" showGuides="1">
      <p:cViewPr>
        <p:scale>
          <a:sx n="170" d="100"/>
          <a:sy n="170" d="100"/>
        </p:scale>
        <p:origin x="58" y="-6941"/>
      </p:cViewPr>
      <p:guideLst>
        <p:guide orient="horz" pos="3005"/>
        <p:guide pos="2038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9B84EA-7D68-4D60-9CB1-D50884785D1C}" type="datetimeFigureOut">
              <a:rPr lang="zh-CN" altLang="en-US" smtClean="0"/>
              <a:t>2026/6/1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4E0FC9-F1F8-4FAE-9988-3BA365CFD4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B776C27-C3F9-4E6F-A81D-E607E105B482}" type="datetimeFigureOut">
              <a:rPr lang="zh-CN" altLang="en-US" smtClean="0"/>
              <a:t>2026/6/1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A8B759-5F3C-4244-B8C3-6E98CC5EE8C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8A8B759-5F3C-4244-B8C3-6E98CC5EE8C2}" type="slidenum">
              <a:rPr lang="zh-CN" altLang="en-US" smtClean="0"/>
              <a:t>2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tags" Target="../tags/tag9.xml"/><Relationship Id="rId2" Type="http://schemas.openxmlformats.org/officeDocument/2006/relationships/tags" Target="../tags/tag8.xml"/><Relationship Id="rId1" Type="http://schemas.openxmlformats.org/officeDocument/2006/relationships/tags" Target="../tags/tag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1.xml"/><Relationship Id="rId4" Type="http://schemas.openxmlformats.org/officeDocument/2006/relationships/tags" Target="../tags/tag10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tags" Target="../tags/tag56.xml"/><Relationship Id="rId2" Type="http://schemas.openxmlformats.org/officeDocument/2006/relationships/tags" Target="../tags/tag55.xml"/><Relationship Id="rId1" Type="http://schemas.openxmlformats.org/officeDocument/2006/relationships/tags" Target="../tags/tag54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57.xml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tags" Target="../tags/tag60.xml"/><Relationship Id="rId2" Type="http://schemas.openxmlformats.org/officeDocument/2006/relationships/tags" Target="../tags/tag59.xml"/><Relationship Id="rId1" Type="http://schemas.openxmlformats.org/officeDocument/2006/relationships/tags" Target="../tags/tag58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62.xml"/><Relationship Id="rId4" Type="http://schemas.openxmlformats.org/officeDocument/2006/relationships/tags" Target="../tags/tag6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tags" Target="../tags/tag14.xml"/><Relationship Id="rId2" Type="http://schemas.openxmlformats.org/officeDocument/2006/relationships/tags" Target="../tags/tag13.xml"/><Relationship Id="rId1" Type="http://schemas.openxmlformats.org/officeDocument/2006/relationships/tags" Target="../tags/tag12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6.xml"/><Relationship Id="rId4" Type="http://schemas.openxmlformats.org/officeDocument/2006/relationships/tags" Target="../tags/tag15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tags" Target="../tags/tag19.xml"/><Relationship Id="rId2" Type="http://schemas.openxmlformats.org/officeDocument/2006/relationships/tags" Target="../tags/tag18.xml"/><Relationship Id="rId1" Type="http://schemas.openxmlformats.org/officeDocument/2006/relationships/tags" Target="../tags/tag1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21.xml"/><Relationship Id="rId4" Type="http://schemas.openxmlformats.org/officeDocument/2006/relationships/tags" Target="../tags/tag20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tags" Target="../tags/tag24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23.xml"/><Relationship Id="rId1" Type="http://schemas.openxmlformats.org/officeDocument/2006/relationships/tags" Target="../tags/tag22.xml"/><Relationship Id="rId6" Type="http://schemas.openxmlformats.org/officeDocument/2006/relationships/tags" Target="../tags/tag27.xml"/><Relationship Id="rId5" Type="http://schemas.openxmlformats.org/officeDocument/2006/relationships/tags" Target="../tags/tag26.xml"/><Relationship Id="rId4" Type="http://schemas.openxmlformats.org/officeDocument/2006/relationships/tags" Target="../tags/tag25.xml"/></Relationships>
</file>

<file path=ppt/slideLayouts/_rels/slideLayout5.xml.rels><?xml version="1.0" encoding="UTF-8" standalone="yes"?>
<Relationships xmlns="http://schemas.openxmlformats.org/package/2006/relationships"><Relationship Id="rId8" Type="http://schemas.openxmlformats.org/officeDocument/2006/relationships/tags" Target="../tags/tag35.xml"/><Relationship Id="rId3" Type="http://schemas.openxmlformats.org/officeDocument/2006/relationships/tags" Target="../tags/tag30.xml"/><Relationship Id="rId7" Type="http://schemas.openxmlformats.org/officeDocument/2006/relationships/tags" Target="../tags/tag34.xml"/><Relationship Id="rId2" Type="http://schemas.openxmlformats.org/officeDocument/2006/relationships/tags" Target="../tags/tag29.xml"/><Relationship Id="rId1" Type="http://schemas.openxmlformats.org/officeDocument/2006/relationships/tags" Target="../tags/tag28.xml"/><Relationship Id="rId6" Type="http://schemas.openxmlformats.org/officeDocument/2006/relationships/tags" Target="../tags/tag33.xml"/><Relationship Id="rId5" Type="http://schemas.openxmlformats.org/officeDocument/2006/relationships/tags" Target="../tags/tag32.xml"/><Relationship Id="rId4" Type="http://schemas.openxmlformats.org/officeDocument/2006/relationships/tags" Target="../tags/tag31.xml"/><Relationship Id="rId9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tags" Target="../tags/tag36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39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tags" Target="../tags/tag42.xml"/><Relationship Id="rId2" Type="http://schemas.openxmlformats.org/officeDocument/2006/relationships/tags" Target="../tags/tag41.xml"/><Relationship Id="rId1" Type="http://schemas.openxmlformats.org/officeDocument/2006/relationships/tags" Target="../tags/tag40.xml"/><Relationship Id="rId4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tags" Target="../tags/tag45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44.xml"/><Relationship Id="rId1" Type="http://schemas.openxmlformats.org/officeDocument/2006/relationships/tags" Target="../tags/tag43.xml"/><Relationship Id="rId6" Type="http://schemas.openxmlformats.org/officeDocument/2006/relationships/tags" Target="../tags/tag48.xml"/><Relationship Id="rId5" Type="http://schemas.openxmlformats.org/officeDocument/2006/relationships/tags" Target="../tags/tag47.xml"/><Relationship Id="rId4" Type="http://schemas.openxmlformats.org/officeDocument/2006/relationships/tags" Target="../tags/tag46.xml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tags" Target="../tags/tag51.xml"/><Relationship Id="rId2" Type="http://schemas.openxmlformats.org/officeDocument/2006/relationships/tags" Target="../tags/tag50.xml"/><Relationship Id="rId1" Type="http://schemas.openxmlformats.org/officeDocument/2006/relationships/tags" Target="../tags/tag49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53.xml"/><Relationship Id="rId4" Type="http://schemas.openxmlformats.org/officeDocument/2006/relationships/tags" Target="../tags/tag5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1"/>
            </p:custDataLst>
          </p:nvPr>
        </p:nvSpPr>
        <p:spPr>
          <a:xfrm>
            <a:off x="674325" y="1320480"/>
            <a:ext cx="5512050" cy="3711901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4500" b="1" i="0" spc="300" baseline="0">
                <a:solidFill>
                  <a:schemeClr val="tx1">
                    <a:lumMod val="85000"/>
                    <a:lumOff val="15000"/>
                  </a:schemeClr>
                </a:solidFill>
                <a:effectLst/>
              </a:defRPr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2"/>
            </p:custDataLst>
          </p:nvPr>
        </p:nvSpPr>
        <p:spPr>
          <a:xfrm>
            <a:off x="674325" y="5141554"/>
            <a:ext cx="5512050" cy="2126285"/>
          </a:xfrm>
        </p:spPr>
        <p:txBody>
          <a:bodyPr lIns="90000" tIns="46800" rIns="90000" bIns="46800">
            <a:normAutofit/>
          </a:bodyPr>
          <a:lstStyle>
            <a:lvl1pPr marL="0" indent="0" algn="ctr" eaLnBrk="1" fontAlgn="auto" latinLnBrk="0" hangingPunct="1">
              <a:lnSpc>
                <a:spcPct val="110000"/>
              </a:lnSpc>
              <a:buNone/>
              <a:defRPr sz="1800" u="none" strike="noStrike" kern="1200" cap="none" spc="20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dirty="0"/>
              <a:t>单击此处编辑副标题</a:t>
            </a:r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6/6/19</a:t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6/6/1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4"/>
            </p:custDataLst>
          </p:nvPr>
        </p:nvSpPr>
        <p:spPr>
          <a:xfrm>
            <a:off x="342225" y="1117729"/>
            <a:ext cx="6172200" cy="7917681"/>
          </a:xfrm>
        </p:spPr>
        <p:txBody>
          <a:bodyPr/>
          <a:lstStyle>
            <a:lvl1pPr marL="171450" indent="-171450" eaLnBrk="1" fontAlgn="auto" latinLnBrk="0" hangingPunct="1">
              <a:lnSpc>
                <a:spcPct val="130000"/>
              </a:lnSpc>
              <a:buFont typeface="Arial" panose="020B0604020202020204" pitchFamily="34" charset="0"/>
              <a:buChar char="●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1pPr>
            <a:lvl2pPr marL="514350" indent="-171450" defTabSz="914400" eaLnBrk="1" fontAlgn="auto" latinLnBrk="0" hangingPunct="1">
              <a:lnSpc>
                <a:spcPct val="120000"/>
              </a:lnSpc>
              <a:buFont typeface="Arial" panose="020B0604020202020204" pitchFamily="34" charset="0"/>
              <a:buChar char="●"/>
              <a:tabLst>
                <a:tab pos="1609725" algn="l"/>
                <a:tab pos="1609725" algn="l"/>
                <a:tab pos="1609725" algn="l"/>
                <a:tab pos="1609725" algn="l"/>
              </a:tabLst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2pPr>
            <a:lvl3pPr marL="857250" indent="-171450" eaLnBrk="1" fontAlgn="auto" latinLnBrk="0" hangingPunct="1">
              <a:lnSpc>
                <a:spcPct val="120000"/>
              </a:lnSpc>
              <a:buFont typeface="Arial" panose="020B0604020202020204" pitchFamily="34" charset="0"/>
              <a:buChar char="●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3pPr>
            <a:lvl4pPr marL="1200150" indent="-171450" eaLnBrk="1" fontAlgn="auto" latinLnBrk="0" hangingPunct="1">
              <a:lnSpc>
                <a:spcPct val="120000"/>
              </a:lnSpc>
              <a:buFont typeface="Wingdings" panose="05000000000000000000" charset="0"/>
              <a:buChar char="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4pPr>
            <a:lvl5pPr marL="1543050" indent="-171450" eaLnBrk="1" fontAlgn="auto" latinLnBrk="0" hangingPunct="1">
              <a:lnSpc>
                <a:spcPct val="120000"/>
              </a:lnSpc>
              <a:buFont typeface="Arial" panose="020B0604020202020204" pitchFamily="34" charset="0"/>
              <a:buChar char="•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6/6/1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4"/>
            </p:custDataLst>
          </p:nvPr>
        </p:nvSpPr>
        <p:spPr>
          <a:xfrm>
            <a:off x="674325" y="3587131"/>
            <a:ext cx="5512050" cy="1471243"/>
          </a:xfrm>
        </p:spPr>
        <p:txBody>
          <a:bodyPr vert="horz" lIns="90000" tIns="46800" rIns="90000" bIns="46800" rtlCol="0" anchor="t" anchorCtr="0">
            <a:normAutofit/>
          </a:bodyPr>
          <a:lstStyle>
            <a:lvl1pPr marL="0" marR="0" algn="ctr" defTabSz="914400" rtl="0" eaLnBrk="1" fontAlgn="auto" latinLnBrk="0" hangingPunct="1">
              <a:lnSpc>
                <a:spcPct val="100000"/>
              </a:lnSpc>
              <a:buNone/>
              <a:defRPr kumimoji="0" lang="zh-CN" altLang="en-US" sz="4500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effectLst/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标题</a:t>
            </a: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5"/>
            </p:custDataLst>
          </p:nvPr>
        </p:nvSpPr>
        <p:spPr>
          <a:xfrm>
            <a:off x="674325" y="5141554"/>
            <a:ext cx="5512050" cy="681035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1800" spc="200" baseline="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42225" y="878587"/>
            <a:ext cx="6170175" cy="1018953"/>
          </a:xfrm>
        </p:spPr>
        <p:txBody>
          <a:bodyPr vert="horz" lIns="90000" tIns="46800" rIns="90000" bIns="46800" rtlCol="0" anchor="ctr" anchorCtr="0">
            <a:normAutofit/>
          </a:bodyPr>
          <a:lstStyle>
            <a:lvl1pPr marL="0" marR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700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2"/>
            </p:custDataLst>
          </p:nvPr>
        </p:nvSpPr>
        <p:spPr>
          <a:xfrm>
            <a:off x="342225" y="2152278"/>
            <a:ext cx="6170175" cy="6872735"/>
          </a:xfrm>
        </p:spPr>
        <p:txBody>
          <a:bodyPr vert="horz" lIns="90000" tIns="46800" rIns="90000" bIns="46800" rtlCol="0">
            <a:normAutofit/>
          </a:bodyPr>
          <a:lstStyle>
            <a:lvl1pPr marL="171450" marR="0" lvl="0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●"/>
              <a:defRPr kumimoji="0" lang="zh-CN" altLang="en-US" sz="135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514350" marR="0" lvl="1" indent="-1714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tabLst>
                <a:tab pos="1609725" algn="l"/>
              </a:tabLst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2pPr>
            <a:lvl3pPr marL="857250" marR="0" lvl="2" indent="-1714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3pPr>
            <a:lvl4pPr marL="1200150" marR="0" lvl="3" indent="-1714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Wingdings" panose="05000000000000000000" charset="0"/>
              <a:buChar char=""/>
              <a:defRPr kumimoji="0" lang="zh-CN" altLang="en-US" sz="105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4pPr>
            <a:lvl5pPr marL="1543050" marR="0" lvl="4" indent="-1714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Arial" panose="020B0604020202020204" pitchFamily="34" charset="0"/>
              <a:buChar char="•"/>
              <a:defRPr kumimoji="0" lang="zh-CN" altLang="en-US" sz="105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5pPr>
            <a:lvl6pPr marL="1714500" indent="0">
              <a:buNone/>
              <a:defRPr/>
            </a:lvl6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6/6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1"/>
            </p:custDataLst>
          </p:nvPr>
        </p:nvSpPr>
        <p:spPr>
          <a:xfrm>
            <a:off x="1119825" y="5557453"/>
            <a:ext cx="4369950" cy="1107332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3300" b="1" i="0" u="none" strike="noStrike" kern="1200" cap="none" spc="300" normalizeH="0" baseline="0">
                <a:solidFill>
                  <a:schemeClr val="tx1">
                    <a:lumMod val="85000"/>
                    <a:lumOff val="15000"/>
                  </a:schemeClr>
                </a:solidFill>
                <a:effectLst/>
                <a:uFillTx/>
              </a:defRPr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1119825" y="6664785"/>
            <a:ext cx="4369950" cy="1252896"/>
          </a:xfrm>
        </p:spPr>
        <p:txBody>
          <a:bodyPr lIns="90000" tIns="46800" rIns="90000" bIns="46800">
            <a:normAutofit/>
          </a:bodyPr>
          <a:lstStyle>
            <a:lvl1pPr marL="0" indent="0" eaLnBrk="1" fontAlgn="auto" latinLnBrk="0" hangingPunct="1">
              <a:lnSpc>
                <a:spcPct val="130000"/>
              </a:lnSpc>
              <a:buNone/>
              <a:defRPr kumimoji="0" lang="zh-CN" altLang="en-US" sz="1350" b="0" i="0" u="none" strike="noStrike" kern="1200" cap="none" spc="150" normalizeH="0" baseline="0" noProof="1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6/6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42225" y="878587"/>
            <a:ext cx="6170175" cy="1018953"/>
          </a:xfrm>
        </p:spPr>
        <p:txBody>
          <a:bodyPr vert="horz" lIns="90000" tIns="46800" rIns="90000" bIns="46800" rtlCol="0" anchor="ctr" anchorCtr="0">
            <a:norm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700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2"/>
            </p:custDataLst>
          </p:nvPr>
        </p:nvSpPr>
        <p:spPr>
          <a:xfrm>
            <a:off x="342225" y="2167875"/>
            <a:ext cx="2911950" cy="6857138"/>
          </a:xfrm>
        </p:spPr>
        <p:txBody>
          <a:bodyPr vert="horz" lIns="90000" tIns="46800" rIns="90000" bIns="46800" rtlCol="0">
            <a:normAutofit/>
          </a:bodyPr>
          <a:lstStyle>
            <a:lvl1pPr marL="171450" marR="0" lvl="0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514350" marR="0" lvl="1" indent="-1714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tabLst>
                <a:tab pos="1609725" algn="l"/>
              </a:tabLst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2pPr>
            <a:lvl3pPr marL="857250" marR="0" lvl="2" indent="-1714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3pPr>
            <a:lvl4pPr marL="1200150" marR="0" lvl="3" indent="-1714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Wingdings" panose="05000000000000000000" charset="0"/>
              <a:buChar char=""/>
              <a:defRPr kumimoji="0" lang="zh-CN" altLang="en-US" sz="105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4pPr>
            <a:lvl5pPr marL="1543050" marR="0" lvl="4" indent="-1714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Arial" panose="020B0604020202020204" pitchFamily="34" charset="0"/>
              <a:buChar char="•"/>
              <a:defRPr kumimoji="0" lang="zh-CN" altLang="en-US" sz="105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3606525" y="2167875"/>
            <a:ext cx="2911950" cy="6857138"/>
          </a:xfrm>
        </p:spPr>
        <p:txBody>
          <a:bodyPr lIns="90000" tIns="46800" rIns="90000" bIns="46800">
            <a:normAutofit/>
          </a:bodyPr>
          <a:lstStyle>
            <a:lvl1pPr marL="171450" indent="-171450" eaLnBrk="1" fontAlgn="auto" latinLnBrk="0" hangingPunct="1">
              <a:lnSpc>
                <a:spcPct val="130000"/>
              </a:lnSpc>
              <a:spcAft>
                <a:spcPts val="600"/>
              </a:spcAft>
              <a:buFont typeface="Arial" panose="020B0604020202020204" pitchFamily="34" charset="0"/>
              <a:buChar char="●"/>
              <a:defRPr sz="12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  <a:lvl2pPr marL="514350" indent="-171450" defTabSz="914400" eaLnBrk="1" fontAlgn="auto" latinLnBrk="0" hangingPunct="1">
              <a:lnSpc>
                <a:spcPct val="120000"/>
              </a:lnSpc>
              <a:buFont typeface="Arial" panose="020B0604020202020204" pitchFamily="34" charset="0"/>
              <a:buChar char="●"/>
              <a:tabLst>
                <a:tab pos="1609725" algn="l"/>
                <a:tab pos="1609725" algn="l"/>
                <a:tab pos="1609725" algn="l"/>
                <a:tab pos="1609725" algn="l"/>
              </a:tabLst>
              <a:defRPr sz="12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2pPr>
            <a:lvl3pPr marL="857250" indent="-171450" eaLnBrk="1" fontAlgn="auto" latinLnBrk="0" hangingPunct="1">
              <a:lnSpc>
                <a:spcPct val="120000"/>
              </a:lnSpc>
              <a:buFont typeface="Arial" panose="020B0604020202020204" pitchFamily="34" charset="0"/>
              <a:buChar char="●"/>
              <a:defRPr sz="12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3pPr>
            <a:lvl4pPr marL="1200150" indent="-171450" eaLnBrk="1" fontAlgn="auto" latinLnBrk="0" hangingPunct="1">
              <a:lnSpc>
                <a:spcPct val="120000"/>
              </a:lnSpc>
              <a:buFont typeface="Wingdings" panose="05000000000000000000" charset="0"/>
              <a:buChar char=""/>
              <a:defRPr sz="105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4pPr>
            <a:lvl5pPr eaLnBrk="1" fontAlgn="auto" latinLnBrk="0" hangingPunct="1">
              <a:lnSpc>
                <a:spcPct val="120000"/>
              </a:lnSpc>
              <a:defRPr sz="1050" u="none" strike="noStrike" kern="1200" cap="none" spc="150" normalizeH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6/6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42225" y="878587"/>
            <a:ext cx="6170175" cy="1018953"/>
          </a:xfrm>
        </p:spPr>
        <p:txBody>
          <a:bodyPr vert="horz" lIns="90000" tIns="46800" rIns="90000" bIns="46800" rtlCol="0" anchor="ctr" anchorCtr="0">
            <a:norm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700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342225" y="2063900"/>
            <a:ext cx="3005100" cy="551066"/>
          </a:xfrm>
        </p:spPr>
        <p:txBody>
          <a:bodyPr lIns="101600" tIns="38100" rIns="76200" bIns="38100" anchor="t" anchorCtr="0">
            <a:normAutofit/>
          </a:bodyPr>
          <a:lstStyle>
            <a:lvl1pPr marL="0" indent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sz="1500" b="1" u="none" strike="noStrike" kern="1200" cap="none" spc="200" normalizeH="0" baseline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342225" y="2677351"/>
            <a:ext cx="3005100" cy="6347662"/>
          </a:xfrm>
        </p:spPr>
        <p:txBody>
          <a:bodyPr vert="horz" lIns="101600" tIns="0" rIns="82550" bIns="0" rtlCol="0">
            <a:normAutofit/>
          </a:bodyPr>
          <a:lstStyle>
            <a:lvl1pPr marL="171450" marR="0" lvl="0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514350" marR="0" lvl="1" indent="-1714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tabLst>
                <a:tab pos="1609725" algn="l"/>
              </a:tabLst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2pPr>
            <a:lvl3pPr marL="857250" marR="0" lvl="2" indent="-1714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3pPr>
            <a:lvl4pPr marL="1200150" marR="0" lvl="3" indent="-1714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Wingdings" panose="05000000000000000000" charset="0"/>
              <a:buChar char=""/>
              <a:defRPr kumimoji="0" lang="zh-CN" altLang="en-US" sz="105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4pPr>
            <a:lvl5pPr marL="1543050" marR="0" lvl="4" indent="-1714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Arial" panose="020B0604020202020204" pitchFamily="34" charset="0"/>
              <a:buChar char="•"/>
              <a:defRPr kumimoji="0" lang="zh-CN" altLang="en-US" sz="105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4"/>
            </p:custDataLst>
          </p:nvPr>
        </p:nvSpPr>
        <p:spPr>
          <a:xfrm>
            <a:off x="3507609" y="2053111"/>
            <a:ext cx="3005100" cy="551066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None/>
              <a:defRPr kumimoji="0" lang="zh-CN" altLang="en-US" sz="1500" b="1" i="0" u="none" strike="noStrike" kern="1200" cap="none" spc="20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>
                <a:sym typeface="+mn-ea"/>
              </a:rPr>
              <a:t>单击此处编辑文本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5"/>
            </p:custDataLst>
          </p:nvPr>
        </p:nvSpPr>
        <p:spPr>
          <a:xfrm>
            <a:off x="3507609" y="2677351"/>
            <a:ext cx="3005100" cy="6347662"/>
          </a:xfrm>
        </p:spPr>
        <p:txBody>
          <a:bodyPr vert="horz" lIns="101600" tIns="0" rIns="82550" bIns="0" rtlCol="0">
            <a:normAutofit/>
          </a:bodyPr>
          <a:lstStyle>
            <a:lvl1pPr marL="171450" marR="0" lvl="0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514350" marR="0" lvl="1" indent="-1714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tabLst>
                <a:tab pos="1609725" algn="l"/>
              </a:tabLst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2pPr>
            <a:lvl3pPr marL="857250" marR="0" lvl="2" indent="-1714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3pPr>
            <a:lvl4pPr marL="1200150" marR="0" lvl="3" indent="-1714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Wingdings" panose="05000000000000000000" charset="0"/>
              <a:buChar char=""/>
              <a:defRPr kumimoji="0" lang="zh-CN" altLang="en-US" sz="105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4pPr>
            <a:lvl5pPr marL="1543050" marR="0" lvl="4" indent="-1714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Arial" panose="020B0604020202020204" pitchFamily="34" charset="0"/>
              <a:buChar char="•"/>
              <a:defRPr kumimoji="0" lang="zh-CN" altLang="en-US" sz="105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6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6/6/1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7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8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42225" y="878587"/>
            <a:ext cx="6170175" cy="1018953"/>
          </a:xfrm>
        </p:spPr>
        <p:txBody>
          <a:bodyPr vert="horz" lIns="90000" tIns="46800" rIns="90000" bIns="46800" rtlCol="0" anchor="ctr" anchorCtr="0">
            <a:norm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700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6/6/1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6/6/1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1"/>
            </p:custDataLst>
          </p:nvPr>
        </p:nvSpPr>
        <p:spPr>
          <a:xfrm>
            <a:off x="342225" y="2245856"/>
            <a:ext cx="2943606" cy="6654388"/>
          </a:xfrm>
        </p:spPr>
        <p:txBody>
          <a:bodyPr vert="horz" lIns="90000" tIns="46800" rIns="90000" bIns="46800" rtlCol="0">
            <a:normAutofit/>
          </a:bodyPr>
          <a:lstStyle>
            <a:lvl1pPr marL="0" marR="0" lvl="0" indent="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None/>
              <a:defRPr kumimoji="0" lang="zh-CN" altLang="en-US" sz="1200" b="0" i="0" u="none" strike="noStrike" kern="1200" cap="none" spc="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514350" marR="0" lvl="1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2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857250" marR="0" lvl="2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200150" marR="0" lvl="3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1543050" marR="0" lvl="4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endParaRPr dirty="0">
              <a:sym typeface="+mn-ea"/>
            </a:endParaRP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2"/>
            </p:custDataLst>
          </p:nvPr>
        </p:nvSpPr>
        <p:spPr>
          <a:xfrm>
            <a:off x="3572100" y="2245856"/>
            <a:ext cx="2940300" cy="6654388"/>
          </a:xfrm>
        </p:spPr>
        <p:txBody>
          <a:bodyPr vert="horz" lIns="90000" tIns="46800" rIns="90000" bIns="46800" rtlCol="0">
            <a:normAutofit/>
          </a:bodyPr>
          <a:lstStyle>
            <a:lvl1pPr marL="0" marR="0" lvl="0" indent="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None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342900" indent="0" defTabSz="914400" eaLnBrk="1" fontAlgn="auto" latinLnBrk="0" hangingPunct="1">
              <a:buFont typeface="Arial" panose="020B0604020202020204" pitchFamily="34" charset="0"/>
              <a:buNone/>
              <a:tabLst>
                <a:tab pos="1609725" algn="l"/>
                <a:tab pos="1609725" algn="l"/>
                <a:tab pos="1609725" algn="l"/>
                <a:tab pos="1609725" algn="l"/>
              </a:tabLst>
              <a:defRPr u="none" strike="noStrike" kern="1200" cap="none" spc="150" normalizeH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</a:defRPr>
            </a:lvl2pPr>
            <a:lvl3pPr eaLnBrk="1" fontAlgn="auto" latinLnBrk="0" hangingPunct="1">
              <a:buFont typeface="Arial" panose="020B0604020202020204" pitchFamily="34" charset="0"/>
              <a:buChar char="●"/>
              <a:defRPr u="none" strike="noStrike" kern="1200" cap="none" spc="150" normalizeH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</a:defRPr>
            </a:lvl3pPr>
            <a:lvl4pPr eaLnBrk="1" fontAlgn="auto" latinLnBrk="0" hangingPunct="1">
              <a:defRPr u="none" strike="noStrike" kern="1200" cap="none" spc="150" normalizeH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</a:defRPr>
            </a:lvl4pPr>
            <a:lvl5pPr eaLnBrk="1" fontAlgn="auto" latinLnBrk="0" hangingPunct="1">
              <a:defRPr u="none" strike="noStrike" kern="1200" cap="none" spc="150" normalizeH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t>2026/6/19</a:t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6"/>
            </p:custDataLst>
          </p:nvPr>
        </p:nvSpPr>
        <p:spPr/>
        <p:txBody>
          <a:bodyPr/>
          <a:lstStyle>
            <a:lvl1pPr>
              <a:defRPr baseline="0"/>
            </a:lvl1pPr>
          </a:lstStyle>
          <a:p>
            <a:r>
              <a:rPr lang="zh-CN" altLang="en-US"/>
              <a:t>单击此处编辑母版标题样式</a:t>
            </a: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1"/>
            </p:custDataLst>
          </p:nvPr>
        </p:nvSpPr>
        <p:spPr>
          <a:xfrm>
            <a:off x="5757075" y="1320480"/>
            <a:ext cx="587250" cy="726264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kumimoji="0" lang="zh-CN" altLang="en-US" sz="2100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标题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2"/>
            </p:custDataLst>
          </p:nvPr>
        </p:nvSpPr>
        <p:spPr>
          <a:xfrm>
            <a:off x="514350" y="1320480"/>
            <a:ext cx="5157675" cy="7262640"/>
          </a:xfrm>
        </p:spPr>
        <p:txBody>
          <a:bodyPr vert="eaVert" lIns="46800" tIns="46800" rIns="46800" bIns="46800"/>
          <a:lstStyle>
            <a:lvl1pPr marL="171450" indent="-171450" eaLnBrk="1" fontAlgn="auto" latinLnBrk="0" hangingPunct="1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●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1pPr>
            <a:lvl2pPr marL="514350" indent="-171450" defTabSz="914400" eaLnBrk="1" fontAlgn="auto" latinLnBrk="0" hangingPunct="1">
              <a:lnSpc>
                <a:spcPct val="120000"/>
              </a:lnSpc>
              <a:spcAft>
                <a:spcPts val="600"/>
              </a:spcAft>
              <a:buFont typeface="Arial" panose="020B0604020202020204" pitchFamily="34" charset="0"/>
              <a:buChar char="●"/>
              <a:tabLst>
                <a:tab pos="1609725" algn="l"/>
                <a:tab pos="1609725" algn="l"/>
                <a:tab pos="1609725" algn="l"/>
                <a:tab pos="1609725" algn="l"/>
              </a:tabLst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2pPr>
            <a:lvl3pPr marL="857250" indent="-171450" eaLnBrk="1" fontAlgn="auto" latinLnBrk="0" hangingPunct="1">
              <a:lnSpc>
                <a:spcPct val="120000"/>
              </a:lnSpc>
              <a:spcAft>
                <a:spcPts val="600"/>
              </a:spcAft>
              <a:buFont typeface="Arial" panose="020B0604020202020204" pitchFamily="34" charset="0"/>
              <a:buChar char="●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3pPr>
            <a:lvl4pPr marL="1200150" indent="-171450" eaLnBrk="1" fontAlgn="auto" latinLnBrk="0" hangingPunct="1">
              <a:lnSpc>
                <a:spcPct val="120000"/>
              </a:lnSpc>
              <a:spcAft>
                <a:spcPts val="300"/>
              </a:spcAft>
              <a:buFont typeface="Wingdings" panose="05000000000000000000" charset="0"/>
              <a:buChar char="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4pPr>
            <a:lvl5pPr marL="1543050" indent="-171450" eaLnBrk="1" fontAlgn="auto" latinLnBrk="0" hangingPunct="1">
              <a:lnSpc>
                <a:spcPct val="120000"/>
              </a:lnSpc>
              <a:spcAft>
                <a:spcPts val="300"/>
              </a:spcAft>
              <a:buFont typeface="Arial" panose="020B0604020202020204" pitchFamily="34" charset="0"/>
              <a:buChar char="•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6/6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ags" Target="../tags/tag1.xml"/><Relationship Id="rId18" Type="http://schemas.openxmlformats.org/officeDocument/2006/relationships/tags" Target="../tags/tag6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17" Type="http://schemas.openxmlformats.org/officeDocument/2006/relationships/tags" Target="../tags/tag5.xml"/><Relationship Id="rId2" Type="http://schemas.openxmlformats.org/officeDocument/2006/relationships/slideLayout" Target="../slideLayouts/slideLayout2.xml"/><Relationship Id="rId16" Type="http://schemas.openxmlformats.org/officeDocument/2006/relationships/tags" Target="../tags/tag4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ags" Target="../tags/tag3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ags" Target="../tags/tag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3"/>
            </p:custDataLst>
          </p:nvPr>
        </p:nvSpPr>
        <p:spPr>
          <a:xfrm>
            <a:off x="342225" y="878587"/>
            <a:ext cx="6170175" cy="1018953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4"/>
            </p:custDataLst>
          </p:nvPr>
        </p:nvSpPr>
        <p:spPr>
          <a:xfrm>
            <a:off x="342225" y="2152278"/>
            <a:ext cx="6170175" cy="6872735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5"/>
            </p:custDataLst>
          </p:nvPr>
        </p:nvSpPr>
        <p:spPr>
          <a:xfrm>
            <a:off x="344250" y="9118590"/>
            <a:ext cx="1518750" cy="4574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75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fld id="{760FBDFE-C587-4B4C-A407-44438C67B59E}" type="datetimeFigureOut">
              <a:rPr lang="zh-CN" altLang="en-US" smtClean="0"/>
              <a:t>2026/6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6"/>
            </p:custDataLst>
          </p:nvPr>
        </p:nvSpPr>
        <p:spPr>
          <a:xfrm>
            <a:off x="2315250" y="9118590"/>
            <a:ext cx="2227500" cy="4574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75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7"/>
            </p:custDataLst>
          </p:nvPr>
        </p:nvSpPr>
        <p:spPr>
          <a:xfrm>
            <a:off x="4993650" y="9118590"/>
            <a:ext cx="1518750" cy="4574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75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  <p:sp>
        <p:nvSpPr>
          <p:cNvPr id="7" name="KSO_TEMPLATE" hidden="1"/>
          <p:cNvSpPr/>
          <p:nvPr>
            <p:custDataLst>
              <p:tags r:id="rId18"/>
            </p:custDataLst>
          </p:nvPr>
        </p:nvSpPr>
        <p:spPr>
          <a:xfrm>
            <a:off x="0" y="0"/>
            <a:ext cx="0" cy="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15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fontAlgn="auto" latinLnBrk="0" hangingPunct="1">
        <a:lnSpc>
          <a:spcPct val="100000"/>
        </a:lnSpc>
        <a:spcBef>
          <a:spcPct val="0"/>
        </a:spcBef>
        <a:buNone/>
        <a:defRPr sz="27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j-cs"/>
        </a:defRPr>
      </a:lvl1pPr>
    </p:titleStyle>
    <p:bodyStyle>
      <a:lvl1pPr marL="1714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3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1pPr>
      <a:lvl2pPr marL="5143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207135" algn="l"/>
          <a:tab pos="1207135" algn="l"/>
          <a:tab pos="1207135" algn="l"/>
          <a:tab pos="1207135" algn="l"/>
        </a:tabLst>
        <a:defRPr sz="12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2pPr>
      <a:lvl3pPr marL="8572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2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3pPr>
      <a:lvl4pPr marL="12001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0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4pPr>
      <a:lvl5pPr marL="15430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0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内容占位符 2"/>
          <p:cNvSpPr>
            <a:spLocks noGrp="1"/>
          </p:cNvSpPr>
          <p:nvPr>
            <p:ph idx="1"/>
          </p:nvPr>
        </p:nvSpPr>
        <p:spPr>
          <a:xfrm>
            <a:off x="970698" y="250229"/>
            <a:ext cx="4916601" cy="360560"/>
          </a:xfrm>
        </p:spPr>
        <p:txBody>
          <a:bodyPr>
            <a:normAutofit/>
          </a:bodyPr>
          <a:lstStyle/>
          <a:p>
            <a:pPr marL="0" indent="0" algn="just" defTabSz="685800">
              <a:lnSpc>
                <a:spcPct val="100000"/>
              </a:lnSpc>
              <a:buNone/>
            </a:pPr>
            <a:r>
              <a:rPr lang="en-US" altLang="zh-CN" sz="1200" b="1" dirty="0">
                <a:solidFill>
                  <a:schemeClr val="tx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1 Primers used for RT-qPCR</a:t>
            </a:r>
            <a:endParaRPr lang="zh-CN" altLang="en-US" sz="1200" b="1" dirty="0">
              <a:solidFill>
                <a:schemeClr val="tx2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表格 1"/>
          <p:cNvGraphicFramePr>
            <a:graphicFrameLocks noGrp="1"/>
          </p:cNvGraphicFramePr>
          <p:nvPr/>
        </p:nvGraphicFramePr>
        <p:xfrm>
          <a:off x="412220" y="731869"/>
          <a:ext cx="6033555" cy="8874243"/>
        </p:xfrm>
        <a:graphic>
          <a:graphicData uri="http://schemas.openxmlformats.org/drawingml/2006/table">
            <a:tbl>
              <a:tblPr/>
              <a:tblGrid>
                <a:gridCol w="115052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56007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32295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N</a:t>
                      </a:r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me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5' to 3'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Description</a:t>
                      </a:r>
                      <a:endParaRPr lang="zh-CN" alt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NF-</a:t>
                      </a:r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α-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CTCGGAACCTCATGGACAG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RT-qPCR of porcine TNF-α mRNA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NF-</a:t>
                      </a:r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α-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R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GGGGTGAGTCAGTGTGACC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IL-6-F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TGCTTCTGGTGATGGCTACTG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RT-qPCR of porcine IL-6 mRNA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IL-6-R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GCATCACCTTTGGCATCTT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IL-8-F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GTTTTCCTGCTTTCTGCAGCT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RT-qPCR of porcine IL-8 mRNA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IL-8-R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GGCATCGAAGTTCTGCACT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IL-1</a:t>
                      </a:r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β-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GCTTACTACAGTGGCAACG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RT-qPCR of porcine IL-1β mRNA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IL-1</a:t>
                      </a:r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β-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R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TCCAGAGGGCAGAGGTCTA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NF-</a:t>
                      </a:r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κ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B1-F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GCAGATGGCCCATATCTTCA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RT-qPCR of porcine NF-κB1 mRNA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NF-</a:t>
                      </a:r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κ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B1-R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TGGGATGGGCCTTCACAAA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NF-</a:t>
                      </a:r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κ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B2-F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AAGCCCAACTCCGGATCTC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RT-qPCR of porcine NF-κB2 mRNA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NF-</a:t>
                      </a:r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κ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B2-R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CCAGAATTTTAGGCGCCCG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NFAIP3-F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TTGTCCCCCTGGTGACCCTGA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RT-qPCR of porcine TNFAIP3 mRNA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NFAIP3-F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TTCGGGATCTGTCAAGAAGTGAAC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IFN-</a:t>
                      </a:r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β-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ATACCAACAAAGGAGCAGCAAT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RT-qPCR of porcine IFN-β mRNA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IFN-</a:t>
                      </a:r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β-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AGCATCTCGTGGATAATCAATAC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ISG20-F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TCCTGCACAAGAGCATCCA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RT-qPCR of porcine ISG20 mRNA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ISG20-R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ATCGTTGCCTTCGCATCT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ELAVL1-F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GAGCAATAAACACGCTGAATGG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RT-qPCR of porcine ELAVL1 mRNA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ELAVL1-R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CCGCTAATATACAAGTTGGCAT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ABPC1-F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CCTACTCTTGCTGGTAAAATCA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RT-qPCR of porcine PABPC1 mRNA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ABPC1-R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ACTTTAGAACGGAGAGACTCTGG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MYC-F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CAGCAACAACCGAAAATGTGCC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RT-qPCR of porcine MYC mRNA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MYC-R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TCTGGGATCTGGTCTCGAAGGG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IGF2-F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TACCGCCCCAGTGAGACTCT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RT-qPCR of porcine IGF2 mRNA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IGF2-R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GCACTCTTCCACGATGCCA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EIF-1-F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TTCTAGATTCTCTCCTGCACGT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8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RT-qPCR of EIF4A3 binding sites in porcine GLIS3 pre-mRNA 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EIF-1-R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ACCCCAATACTCACCCAGTTAT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EIF-2-F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TTTCCACTAGACACCAACTTGA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EIF-2-R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GCAGCAACATTTTTACTAGCCA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EIF-3-F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TACTGCGTACTTCAAGGTTATGAG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EIF-3-R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TGTGAAAGTGGAAGGCAGG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EIF-4-F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TCACTAAATGTGTGAAATACATAAATC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EIF-4-R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TAATACTTGCCTTACAATTATCACCT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IGF-1-F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TTACCAAATACATTTCAGTCAAG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18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RT-qPCR of IGF2BP2 binding sites in porcine GLIS3 pre-mRNA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IGF-1-R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AAAAAGTTAGAGACCTTGGAA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IGF-2-F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GGCTCAGCAGTTAGTGAACCTG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IGF-2-R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AACAAGGGATCCTAGCTGTGTCT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IGF-3-F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GCTACAGCTCTAATTGGACCC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IGF-3-R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ATGGATACTAGTTGGGTTTGTTAC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4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IGF-4-F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CTGATTTGACTGTCTAGCCTGGGA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4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IGF-4-R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AAACACCAGGCTTTTAGTTCCAGG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4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IGF-5-F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AATTGATTTCCACTAGACACCAACT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4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IGF-5-R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TTACTAGCCAAGTTGTTAAGTGTGAG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4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IGF-6-F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CTGCGTACTTCAAGGTTATGAGACTAG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4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IGF-6-R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CAGCACCTAAAGCACAGTCCAT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4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IGF-7-F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TTCTTTCTCCCTGCCTTCCACTTT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4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IGF-7-R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AGATTATGCAAAGCCACCCTGGAC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4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IGF-8-F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TTGCATAATCTCAGACAGCTCACTT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4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IGF-8-R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GAAGGGACATTAGCTGGTGGAC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5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IGF-9-F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CTAATGTCCCTTCTTTCTGTAGTGTC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5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IGF-9-R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GCCTTACAATTATCACCTGTTTGG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5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IGF2BP2-mRNA-F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GAGGTATTGGATGGACTTTTGG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RT-qPCR of porcine IGF2BP2 mRNA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5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IGF2BP2-mRNA-R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TCTCTTGTTGCATATGTGACGTTG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5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EIF4A3-mRNA-F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CAGGAAACTGGACTATGGACAGC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RT-qPCR of porcine EIF4A3 mRNA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5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EIF4A3-mRNA-R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AGCCTCATCCAAAACCAACATC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5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ig-circGLIS3-F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GGAGGACTTCACTTGCTTCTGG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RT-qPCR of porcine circGLIS3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5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ig-circGLIS3-R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ACTCCAAAGACTCACGGGAAATAA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5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human-circGLIS3-F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CAACAAGTGTACGGTCCG 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RT-qPCR of human circGLIS3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5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human-circGLIS3-R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GAAAAGGTAGGGTGGCAAC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6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ig-circTNFAIP3-F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CATCCACAAAGCTCTCATCGACAG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RT-qPCR of porcine circTNFAIP3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6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ig-circTNFAIP3-R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GCTCAGCCATGGTGCTCTACAAG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62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内容占位符 2"/>
          <p:cNvSpPr>
            <a:spLocks noGrp="1"/>
          </p:cNvSpPr>
          <p:nvPr>
            <p:ph idx="1"/>
          </p:nvPr>
        </p:nvSpPr>
        <p:spPr>
          <a:xfrm>
            <a:off x="889159" y="65159"/>
            <a:ext cx="4916601" cy="360560"/>
          </a:xfrm>
        </p:spPr>
        <p:txBody>
          <a:bodyPr>
            <a:normAutofit/>
          </a:bodyPr>
          <a:lstStyle/>
          <a:p>
            <a:pPr marL="0" indent="0" algn="ctr" defTabSz="685800">
              <a:lnSpc>
                <a:spcPct val="100000"/>
              </a:lnSpc>
              <a:buNone/>
            </a:pPr>
            <a:r>
              <a:rPr lang="en-US" altLang="zh-CN" sz="1200" b="1" dirty="0">
                <a:solidFill>
                  <a:schemeClr val="tx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1 Continued</a:t>
            </a:r>
            <a:endParaRPr lang="zh-CN" altLang="en-US" sz="1200" b="1" dirty="0">
              <a:solidFill>
                <a:schemeClr val="tx2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8" name="表格 7"/>
          <p:cNvGraphicFramePr>
            <a:graphicFrameLocks noGrp="1"/>
          </p:cNvGraphicFramePr>
          <p:nvPr/>
        </p:nvGraphicFramePr>
        <p:xfrm>
          <a:off x="412222" y="553851"/>
          <a:ext cx="6169025" cy="7338834"/>
        </p:xfrm>
        <a:graphic>
          <a:graphicData uri="http://schemas.openxmlformats.org/drawingml/2006/table">
            <a:tbl>
              <a:tblPr/>
              <a:tblGrid>
                <a:gridCol w="140493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74319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02089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N</a:t>
                      </a:r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me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3701" marR="3701" marT="37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5' to 3'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Description</a:t>
                      </a:r>
                      <a:endParaRPr lang="zh-CN" alt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3701" marR="3701" marT="3701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LIS3-mRNA-F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GCTCATCGATGCATGGTACCGCCACC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RT-qPCR of porcine GLIS3 mRNA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LIS3-mRNA-R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AAAAGATCTGCTAGCTCGAGTTAGCC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LIS3-pre-mRNA-up-F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CGAGAAGCCCTATTTGT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4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RT-qPCR of porcine GLIS3 pre-mRNA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LIS3-pre-mRNA-up-R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GCGTTTGGTGCATCCTG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LIS3-pre-mRNA-down-F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CCGCTATAAACTGCTCATCCAC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LIS3-pre-mRNA-down-R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AGAAAAGGCCCTCTGACTTCC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ig-GAPDH-F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GGTGAAGGTCGGAGTGAAC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RT-qPCR of porcine GAPDH mRNA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ig-GAPDH-R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GAAGATGGTGATGGGATTTC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human-GAPDH-F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TCAAGGCTGAGAACGGGAA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RT-qPCR of human GAPDH mRNA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human-GAPDH-R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AATGAGCCCCAGCCTTCTC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U6-F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TTGGAACGATACAGAGAAGATT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RT-qPCR of porcine U6 mRNA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U6-R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GAACGCTTCACGAATTTG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m</a:t>
                      </a:r>
                      <a:r>
                        <a:rPr lang="en-US" sz="9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6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-351-F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ACTCATTGCCATCCTACCTTTTTG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14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RT-qPCR of predicted porcine circGLIS3 m</a:t>
                      </a:r>
                      <a:r>
                        <a:rPr lang="en-US" sz="9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6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 sites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m</a:t>
                      </a:r>
                      <a:r>
                        <a:rPr lang="en-US" sz="9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6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-351-R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TAGACCTCAGGCTGTGGCGAC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m</a:t>
                      </a:r>
                      <a:r>
                        <a:rPr lang="en-US" sz="9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6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-663-F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GCGTGGCAGCTGTATTCC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m</a:t>
                      </a:r>
                      <a:r>
                        <a:rPr lang="en-US" sz="9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6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-663-R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TGGCTGGCCTTCAGGGT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m</a:t>
                      </a:r>
                      <a:r>
                        <a:rPr lang="en-US" sz="9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6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-695-F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GCCGGCTTGCTTAAGACTGAA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m</a:t>
                      </a:r>
                      <a:r>
                        <a:rPr lang="en-US" sz="9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6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-695-R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CTCCCCATCCTCGTCCAG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m</a:t>
                      </a:r>
                      <a:r>
                        <a:rPr lang="en-US" sz="9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6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-894-F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GGATCTGCCCCCGGCAC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m</a:t>
                      </a:r>
                      <a:r>
                        <a:rPr lang="en-US" sz="9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6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-894-R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GCACTGCAATCAATCCAACGAC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m</a:t>
                      </a:r>
                      <a:r>
                        <a:rPr lang="en-US" sz="9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6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-958-F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TGGGAGCAAGCACTGCTGTC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m</a:t>
                      </a:r>
                      <a:r>
                        <a:rPr lang="en-US" sz="9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6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-958-R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CCCCTTTGCGCTGATCTATATG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m</a:t>
                      </a:r>
                      <a:r>
                        <a:rPr lang="en-US" sz="9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6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-1008-F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TGCGGCACATCGAGAAGATTCA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m</a:t>
                      </a:r>
                      <a:r>
                        <a:rPr lang="en-US" sz="9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6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-1008-R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TAGCGGGCATTGAATGGCTTGTAC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m</a:t>
                      </a:r>
                      <a:r>
                        <a:rPr lang="en-US" sz="9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6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-1069-F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CACTTGCTTCTGGGCAGGTTGTC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m</a:t>
                      </a:r>
                      <a:r>
                        <a:rPr lang="en-US" sz="9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6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-1069-R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GAACACTTATTGGGCTTCTCTCCG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DCoV-</a:t>
                      </a:r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M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-F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TGATGTCTGACGCAGAAGAGTGGC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3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RT-qPCR of PDCoV M gene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DCoV-</a:t>
                      </a:r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M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-R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CGTTACATATACTTATACAGGCGAGCG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154923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robe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AM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-CACACCAGTCGTTAAGCATGGCAAGCT-</a:t>
                      </a:r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BHQ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mini-F-1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GGCCTCAGTGCAAGTCCAT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RT-qPCR of minigene splicing isoforms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mini-R-1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TGGCACGGTCACTGGAGTTACT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mouse-GAPDH-F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GCGACTTCAACAGCAACTC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RT-qPCR of mouse GAPDH mRNA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mouse-GAPDH-R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TTGCTCAGTGTCCTTGCTG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at-GAPDH-F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CCATCAATGACCCCTTCAT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RT-qPCR of cat GAPDH mRNA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3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at-GAPDH-R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CCGTGGAATTTGCCGT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dog-GAPDH-F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GTGACACCCACTCTTCCACCT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RT-qPCR of dog GAPDH mRNA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3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dog-GAPDH-R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TGGTCCAGGAGGCTCTTACTC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vero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-actin-F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CCCTGGAGAAGAGCTACGA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RT-qPCR of monkey GAPDH mRNA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3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vero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-actin-R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GCACTGTGTTGGCGTACAG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hi-GAPDH-F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CAGCAACATCAAATGGGCAGAT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RT-qPCR of chicken GAPDH mRNA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4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hi-GAPDH-R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GATAACACGCTTAGCACCACCCT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4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mouse-circGLIS3-F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AGATACAAGCCTTTCAACGCAC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RT-qPCR of mouse circGLIS3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4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mouse-circGLIS3-R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CAGACTCAAAGTCGTGGACACC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4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at-circGLIS3-F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ATCCACATGCGAGTCCACTCC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RT-qPCR of cat circGLIS3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4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at-circGLIS3-R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CTTGTTTCACGCTCAAGGCC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4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dog-circGLIS3-F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ACAAGCCATTCAACGCCCGAT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RT-qPCR of dog circGLIS3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4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dog-circGLIS3-R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CCACTCCTGTTTCACGCTCAAG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4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vero-circGLIS3-F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AAGCATTGCTGCCGCTGGAT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RT-qPCR of monkey circGLIS3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4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vero-circGLIS3-R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TCACGCTGGAGGCCGACTGA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4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hi-circGLIS3-F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TGTCCTAGAAGGTTCAAGCCAT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RT-qPCR of chicken circGLIS3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5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hi-circGLIS3-R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GTAGAGTCCAGAGAATTGTGCG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51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内容占位符 2"/>
          <p:cNvSpPr>
            <a:spLocks noGrp="1"/>
          </p:cNvSpPr>
          <p:nvPr>
            <p:ph idx="1"/>
          </p:nvPr>
        </p:nvSpPr>
        <p:spPr>
          <a:xfrm>
            <a:off x="889159" y="65159"/>
            <a:ext cx="4916601" cy="360560"/>
          </a:xfrm>
        </p:spPr>
        <p:txBody>
          <a:bodyPr>
            <a:normAutofit/>
          </a:bodyPr>
          <a:lstStyle/>
          <a:p>
            <a:pPr marL="0" indent="0" algn="ctr" defTabSz="685800">
              <a:lnSpc>
                <a:spcPct val="100000"/>
              </a:lnSpc>
              <a:buNone/>
            </a:pPr>
            <a:r>
              <a:rPr lang="en-US" altLang="zh-CN" sz="1200" b="1" dirty="0">
                <a:solidFill>
                  <a:schemeClr val="tx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1 Continued</a:t>
            </a:r>
            <a:endParaRPr lang="zh-CN" altLang="en-US" sz="1200" b="1" dirty="0">
              <a:solidFill>
                <a:schemeClr val="tx2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表格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1004387"/>
              </p:ext>
            </p:extLst>
          </p:nvPr>
        </p:nvGraphicFramePr>
        <p:xfrm>
          <a:off x="421728" y="553851"/>
          <a:ext cx="6159519" cy="4225830"/>
        </p:xfrm>
        <a:graphic>
          <a:graphicData uri="http://schemas.openxmlformats.org/drawingml/2006/table">
            <a:tbl>
              <a:tblPr/>
              <a:tblGrid>
                <a:gridCol w="139542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74319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02089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N</a:t>
                      </a:r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me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3701" marR="3701" marT="37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5' to 3'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Description</a:t>
                      </a:r>
                      <a:endParaRPr lang="zh-CN" alt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3701" marR="3701" marT="3701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</a:t>
                      </a:r>
                      <a:r>
                        <a:rPr lang="en-US" altLang="zh-C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ro-P1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-F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ACTCATTGCCATCCTACCTTTTTG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7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qPCR of predicted IGF2BP2 binding sites in </a:t>
                      </a:r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LIS3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 promoter</a:t>
                      </a: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</a:t>
                      </a:r>
                      <a:r>
                        <a:rPr lang="en-US" altLang="zh-C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ro-P1-R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TAGACCTCAGGCTGTGGCGAC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</a:t>
                      </a:r>
                      <a:r>
                        <a:rPr lang="en-US" altLang="zh-C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ro-P2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-F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GCGTGGCAGCTGTATTCC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ro-P2-R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TGGCTGGCCTTCAGGGT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ro-P3-F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GCCGGCTTGCTTAAGACTGAA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ro-P3-R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CTCCCCATCCTCGTCCAG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27539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ro-P4-F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GGATCTGCCCCCGGCAC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</a:t>
                      </a:r>
                      <a:r>
                        <a:rPr lang="en-US" altLang="zh-C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ro-P4-R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AAAAATCCGGTAGTAAAATGGAAA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NF-α-P1-F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CAGAGTGAGGACACCAGGGGAC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NF-α-P1-R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GTGTCTTTTTCAGAGGGGCTCAGG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NF-α-P2-F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TGGCCCCTTGAGCATCAA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NF-α-P2-R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ACAGCCCATCTGTCGGCAC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NF-α-P3-F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GTCTCCTACCAGACCAAGGTCAAC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NF-α-P3-R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GCCCAGATTCAGCAAAGTCCA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NF-α-P4-F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AGGACATCCGTTCCCTCCC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NF-α-P4-R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CTGGTTGTCCAGGCCACA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NF-α-P5-F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CACTGACCACCACCAAGAA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3"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RT-qPCR of predicted IGF2BP2 binding sites in </a:t>
                      </a:r>
                      <a:r>
                        <a:rPr lang="en-US" altLang="zh-CN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NF-α </a:t>
                      </a:r>
                      <a:r>
                        <a:rPr lang="en-US" altLang="zh-C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mRNA</a:t>
                      </a:r>
                    </a:p>
                    <a:p>
                      <a:pPr algn="l" fontAlgn="ctr">
                        <a:buNone/>
                      </a:pP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NF-α-P5-R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GGAAGCCTAAAAAGTCATCAAGAT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NF-α-P6-F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GGTGTCCTGGGAGACCCA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NF-α-P6-R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TACAGACACAACTCCCCTGG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NF-α-P7-F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TAGGATTCCCTGGGCTTCACT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NF-α-P7-R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TTCAGCCGGAAGTCTCACCT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NF-α-P8-F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GGGAGCGGCCAGATGCT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NF-α-P8-R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CTCTACAAGGCGCTCAGATGTCA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NF-α-P9-F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AAAATGTGGGTGAAGGGCC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NF-α-P9-R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ACAGATCCTTAACCCAATGAGTGA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NF-α-P10-F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TGAGGTTGCGGGTTCCATC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NF-α-P10-R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TTCTGTTTGTTTTTTAGGGCCAAA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0">
                <a:tc gridSpan="3"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bbreviations:  F, Forward; R, Reverse.</a:t>
                      </a:r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 marL="3701" marR="3701" marT="370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 marL="3701" marR="3701" marT="3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格 4"/>
          <p:cNvGraphicFramePr>
            <a:graphicFrameLocks noGrp="1"/>
          </p:cNvGraphicFramePr>
          <p:nvPr/>
        </p:nvGraphicFramePr>
        <p:xfrm>
          <a:off x="211393" y="582959"/>
          <a:ext cx="6543368" cy="9148725"/>
        </p:xfrm>
        <a:graphic>
          <a:graphicData uri="http://schemas.openxmlformats.org/drawingml/2006/table">
            <a:tbl>
              <a:tblPr/>
              <a:tblGrid>
                <a:gridCol w="170098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51503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32735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Name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Sequence (5'-3')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Description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-circGLIS3-up-F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TTGGTACCGAGCTCGTAGGCCAGTAGCTACAGCTCTGAT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8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circGLIS3 W/M overexpression and control plasmids construction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-circGLIS3-up-R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GCTGGATATCTGCAGAATTCGAAAACCACATGCACCTTCAAT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-circGLIS3-down-F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TGCATGTGGTTTTCTAAAGGCTGGCACTCACTGGAAT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-circGLIS3-down-R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ACGGGCCCTCTAGAGTAGGCCAGTAGCTACAGCTCTGAT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-up-F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TTGGTACCGAGCTCGTAGGCCAGTAGCTACAGCTCTGAT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-up-R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GCTGGATATCTGCAGAATTCCTGGAACAGCAGCCAGAAGGAG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-down-F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GGCTGCTGTTCCAGGAATTCGTGAGTCTCCTAAAGCCCATGG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-down-R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ACGGGCCCTCTAGAGTAGGCCAGTAGCTACAGCTCTGAT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IRES</a:t>
                      </a:r>
                      <a:r>
                        <a:rPr lang="en-US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-216-18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/IRES</a:t>
                      </a:r>
                      <a:r>
                        <a:rPr lang="en-US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-216-184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-F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AAAATGAACAATAAAAGCACTGCTGTCGTTGGATTGATT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8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Rluc/Fluc-IRES plasmids construction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IRES</a:t>
                      </a:r>
                      <a:r>
                        <a:rPr lang="en-US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85-184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/IRES</a:t>
                      </a:r>
                      <a:r>
                        <a:rPr lang="en-US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-216-184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-R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TTGGCGTCTTCCATGGCTGTCCCAGGAGGAAGGCTAA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IRES</a:t>
                      </a:r>
                      <a:r>
                        <a:rPr lang="en-US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-216-18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-R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TTGGCGTCTTCCATTCACGGGAAATAAGGGACCGAACAC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IRES</a:t>
                      </a:r>
                      <a:r>
                        <a:rPr lang="en-US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9-118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-F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AAAATGAACAATAAGTCTTTGGAGTCCTCAACTTTGAGT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IRES</a:t>
                      </a:r>
                      <a:r>
                        <a:rPr lang="en-US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9-118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-R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TTGGCGTCTTCCATGGAGAGCGAAGGGAGAGACCT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IRES</a:t>
                      </a:r>
                      <a:r>
                        <a:rPr lang="en-US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85-184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-F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AAAATGAACAATAAGTCTCAGGGCTACAGGTCTCTCCCT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IRES</a:t>
                      </a:r>
                      <a:r>
                        <a:rPr lang="en-US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9-184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-F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AAAATGAACAATAAGTCTTTGGAGTCCTCAACTTTGAGT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IRES</a:t>
                      </a:r>
                      <a:r>
                        <a:rPr lang="en-US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9-184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-R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TTGGCGTCTTCCATGGAGAGCGAAGGGAGAGACCT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ircGLIS3-up-flag-TGA-F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GGCTGCTGTTCCAGGTCCCTTATTTCCCGGATTACAAGG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10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pcDNA3.1-ORF1/2 and pc-circGLIS3-ORF1/2 plasmids construction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ircGLIS3-up-flag-TGA-R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GCTGTCCCAGGAGGAAGGCTAA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ircGLIS3-down-flag-TGA-F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TCCTCCTGGGACAGCCATGTCTGGCAACGGGGTCTCTAACT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ircGLIS3-down-flag-TGA-F-M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TCCTCCTGGGACAGCCACGTCTGGCAACGGGGTCTCTAACT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ircGLIS3-down-flag-TGA-R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TTTAGGAGACTCACCGAACACTTATTGGGCTTCTCTCCG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ircGLIS3-up-flag-ATG-F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GGCTGCTGTTCCAGGTCCCTTATTTCCCGTGAGTCTTTG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ircGLIS3-up-flag-ATG-R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TTGTCATCGTCGTCCTTGTAATCCATGGCTGTCCCAGGAGGAAGGCTA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ircGLIS3-up-flag-ATG-R-M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TTGTCATCGTCGTCCTTGTAATCCGTGGCTGTCCCAGGAGGAAGGCTA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ircGLIS3-down-flag-ATG-F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ACGACGATGACAAGTCTGGCAACGGGGTCTCTAACTCAT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ircGLIS3-down-flag-ATG-R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TTTAGGAGACTCACCGAACACTTATTGGGCTTCTCTCCG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ircGLIS3-pmir-F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AAACGAGCTCGCTAGCGTCCCTTATTTCCCGTGAGTCTTTG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4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pmir-circGLIS3-full-WT/mut and pmir-circGLIS3-target-WT/mut plasmids construction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ircGLIS3-pmir-R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AGGTCGACTCTAGACGAACACTTATTGGGCTTCTCTCCG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ircGLIS3-578-1-F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AAACGAGCTCGCTAGCGTCCCTTATTTCCCGTGAGTCTTTG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ircGLIS3-578-1-R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ACCGACCAGATCAGGGTCCGGCAGGCCGT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ircGLIS3-578-2-F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TGATCTGGTCGGTTCCGGCTTGCTTAAGACTGAACG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ircGLIS3-578-2-R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ACCGACCAGGTGGTGGATGAGCTCCGGGT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ircGLIS3-578-3-F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CCACCTGGTCGGTTTGGCCCTCACACAGGCAGCC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ircGLIS3-578-3-R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AGGTCGACTCTAGACGAACACTTATTGGGCTTCTCTCCG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ircGLIS3-878-1-F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AAACGAGCTCGCTAGCGTCCCTTATTTCCCGTGAGTCTTTG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ircGLIS3-878-1-R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GTGGGCGTGACCCTTCTGGCTGCTTGGCATG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ircGLIS3-878-2-F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AGGGTCACGCCCACTCCAGCAGCGGCCCGGCTCT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ircGLIS3-878-2-R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AGGTCGACTCTAGACGAACACTTATTGGGCTTCTCTCCG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W-circGLIS3-578-1-F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GCCGGACCCTGAAGGCCAGCCAGC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W-circGLIS3-578-1-R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CGAGCTGGCTGGCCTTCAGGGTCCGGCGAGCT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4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M-circGLIS3-578-1-F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GCCGGACCCTGATCTGGTCGGTGC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4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M-circGLIS3-578-1-R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CGAGCACCGACCAGATCAGGGTCCGGCGAGCT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4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W-circGLIS3-578-2-F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GCTCATCCACCACGCCCAGCCATC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4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W-circGLIS3-578-2-R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CGAGATGGCTGGGCGTGGTGGATGAGCGAGCT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4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M-circGLIS3-578-2-F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GCTCATCCACCACCTGGTCGGTTC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4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M-circGLIS3-578-2-R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CGAGAACCGACCAGGTGGTGGATGAGCGAGCT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4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W-circGLIS3-878-F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AAGCAGCCAGAAGGGTGTGCGGGTGGC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4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W-circGLIS3-878-R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CGAGCCACCCGCACACCCTTCTGGCTGCTTGAGCT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4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M-circGLIS3-878-F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AAGCAGCCACTTCCGTCACGCCCACC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4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M-circGLIS3-878-R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CGAGGTGGGCGTGACGGAAGTGGCTGCTTGAGCT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5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aggs-flag-IGF2BP2-F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ATGACGACGATAAGATGATGAACAAGCTTTACATCGGGA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2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IGF2BP2-WT/mut overexpression plasmids construction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5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aggs-flag-IGF2BP2-R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TTAAGATCTGCTAGTCACAGCACAGGTACCTGGCT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5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aggs-flag-IGF2BP2-RRM-F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ATGACGACGATAAGATGATGAACAAGTCCTACATCCCGGATGAAGAG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5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aggs-flag-IGF2BP2-RRM-R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TTAAGATCTGCTAGTCACAGCACAGGTACCTGGCT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5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aggs-flag-IGF2BP2-KH 1-4-up-F</a:t>
                      </a:r>
                    </a:p>
                  </a:txBody>
                  <a:tcPr marL="3405" marR="3405" marT="340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ATGACGACGATAAGATGATGAACAAGCTTTACATCGGG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5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aggs-flag-IGF2BP2-KH 1-4-up-R</a:t>
                      </a:r>
                    </a:p>
                  </a:txBody>
                  <a:tcPr marL="3405" marR="3405" marT="340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ATGATGGCACCAACAAACTGG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5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aggs-flag-IGF2BP2-KH 1-4-middle-F</a:t>
                      </a:r>
                    </a:p>
                  </a:txBody>
                  <a:tcPr marL="3405" marR="3405" marT="340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TGTTGGTGCCATCATCGGAGAGGAGGGCTTGACCATAAAGA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5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aggs-flag-IGF2BP2-KH 1-4-middle-R</a:t>
                      </a:r>
                    </a:p>
                  </a:txBody>
                  <a:tcPr marL="3405" marR="3405" marT="340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CCTTCTTCTCCAATCAGTCTTCCA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5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aggs-flag-IGF2BP2-KH 1-4-down-F</a:t>
                      </a:r>
                    </a:p>
                  </a:txBody>
                  <a:tcPr marL="3405" marR="3405" marT="340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GATTGGAGAAGAAGGCAGAAATTTGAAGAAAATTGAACATGAG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5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aggs-flag-IGF2BP2-KH 1-4-down-R</a:t>
                      </a:r>
                    </a:p>
                  </a:txBody>
                  <a:tcPr marL="3405" marR="3405" marT="340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TTAAGATCTGCTAGTCACAGCACAGGTACCTGGCT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6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aggs-flag-IGF2BP2-KH 3-4-up-F</a:t>
                      </a:r>
                    </a:p>
                  </a:txBody>
                  <a:tcPr marL="3405" marR="3405" marT="340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ATGACGACGATAAGATGATGAACAAGCTTTACATCGGG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6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aggs-flag-IGF2BP2-KH 3-4-up-R</a:t>
                      </a:r>
                    </a:p>
                  </a:txBody>
                  <a:tcPr marL="3405" marR="3405" marT="340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ATGATGGCACCCACGGC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6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aggs-flag-IGF2BP2-KH 3-4-middle-F</a:t>
                      </a:r>
                    </a:p>
                  </a:txBody>
                  <a:tcPr marL="3405" marR="3405" marT="340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TGGGTGCCATCATCGGGGAGGAAGGAGCGCACATTAA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6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aggs-flag-IGF2BP2-KH 3-4-middle-R</a:t>
                      </a:r>
                    </a:p>
                  </a:txBody>
                  <a:tcPr marL="3405" marR="3405" marT="340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CCTTCCTCGCCAATCACACG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6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aggs-flag-IGF2BP2-KH 3-4-down-F</a:t>
                      </a:r>
                    </a:p>
                  </a:txBody>
                  <a:tcPr marL="3405" marR="3405" marT="340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TTGGCGAGGAAGGCAAAACCGTGAATGAACTGCAGAACT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6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aggs-flag-IGF2BP2-KH 3-4-down-R</a:t>
                      </a:r>
                    </a:p>
                  </a:txBody>
                  <a:tcPr marL="3405" marR="3405" marT="340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TTAAGATCTGCTAGTCACAGCACAGGTACCTGGCTG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6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aggs-flag-IGF2BP2-KH 1-2-up-F</a:t>
                      </a:r>
                    </a:p>
                  </a:txBody>
                  <a:tcPr marL="3405" marR="3405" marT="340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ATGACGACGATAAGATGATGAACAAGCTTTACATCGGGA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6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aggs-flag-IGF2BP2-KH 1-2-up-R</a:t>
                      </a:r>
                    </a:p>
                  </a:txBody>
                  <a:tcPr marL="3405" marR="3405" marT="340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ATCAGTCTTCCAACCAAGCCATTG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6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aggs-flag-IGF2BP2-KH 1-2-middle-F</a:t>
                      </a:r>
                    </a:p>
                  </a:txBody>
                  <a:tcPr marL="3405" marR="3405" marT="340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GCTTGGTTGGAAGACTGATTGGAGAAGAAGGCAGAAATTTGAAG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aggs-flag-IGF2BP2-KH 1-2-middle-R</a:t>
                      </a:r>
                    </a:p>
                  </a:txBody>
                  <a:tcPr marL="3405" marR="3405" marT="340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TTAAGATCTGCTAGTCACAGCACAGGTACCTGGCTG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7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aggs-flag-IGF2BP2-KH 1-2-down-F</a:t>
                      </a:r>
                    </a:p>
                  </a:txBody>
                  <a:tcPr marL="3405" marR="3405" marT="340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GAGAAGAAGGCAGAAATTTGAAG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7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aggs-flag-IGF2BP2-KH 1-2-down-R</a:t>
                      </a:r>
                    </a:p>
                  </a:txBody>
                  <a:tcPr marL="3405" marR="3405" marT="340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TTAAGATCTGCTAGTCACAGCACAGGTACCTGGCT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72"/>
                  </a:ext>
                </a:extLst>
              </a:tr>
            </a:tbl>
          </a:graphicData>
        </a:graphic>
      </p:graphicFrame>
      <p:sp>
        <p:nvSpPr>
          <p:cNvPr id="6" name="内容占位符 2"/>
          <p:cNvSpPr>
            <a:spLocks noGrp="1"/>
          </p:cNvSpPr>
          <p:nvPr>
            <p:ph idx="1"/>
          </p:nvPr>
        </p:nvSpPr>
        <p:spPr>
          <a:xfrm>
            <a:off x="621247" y="130371"/>
            <a:ext cx="5499991" cy="360560"/>
          </a:xfrm>
        </p:spPr>
        <p:txBody>
          <a:bodyPr>
            <a:noAutofit/>
          </a:bodyPr>
          <a:lstStyle/>
          <a:p>
            <a:pPr marL="0" indent="0" algn="just" defTabSz="685800">
              <a:lnSpc>
                <a:spcPct val="100000"/>
              </a:lnSpc>
              <a:buNone/>
            </a:pPr>
            <a:r>
              <a:rPr lang="en-US" altLang="zh-CN" sz="1200" b="1" dirty="0">
                <a:solidFill>
                  <a:schemeClr val="tx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2 Primers used for plasmid constructions</a:t>
            </a:r>
            <a:endParaRPr lang="zh-CN" altLang="en-US" sz="1200" b="1" dirty="0">
              <a:solidFill>
                <a:schemeClr val="tx2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内容占位符 2"/>
          <p:cNvSpPr>
            <a:spLocks noGrp="1"/>
          </p:cNvSpPr>
          <p:nvPr>
            <p:ph idx="1"/>
          </p:nvPr>
        </p:nvSpPr>
        <p:spPr>
          <a:xfrm>
            <a:off x="970699" y="171141"/>
            <a:ext cx="4916601" cy="360560"/>
          </a:xfrm>
        </p:spPr>
        <p:txBody>
          <a:bodyPr>
            <a:normAutofit/>
          </a:bodyPr>
          <a:lstStyle/>
          <a:p>
            <a:pPr marL="0" indent="0" algn="ctr" defTabSz="685800">
              <a:lnSpc>
                <a:spcPct val="100000"/>
              </a:lnSpc>
              <a:buNone/>
            </a:pPr>
            <a:r>
              <a:rPr lang="en-US" altLang="zh-CN" sz="1200" b="1" dirty="0">
                <a:solidFill>
                  <a:schemeClr val="tx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2 Continued</a:t>
            </a:r>
            <a:endParaRPr lang="zh-CN" altLang="en-US" sz="1200" b="1" dirty="0">
              <a:solidFill>
                <a:schemeClr val="tx2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表格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91276611"/>
              </p:ext>
            </p:extLst>
          </p:nvPr>
        </p:nvGraphicFramePr>
        <p:xfrm>
          <a:off x="154856" y="591470"/>
          <a:ext cx="6624690" cy="8778610"/>
        </p:xfrm>
        <a:graphic>
          <a:graphicData uri="http://schemas.openxmlformats.org/drawingml/2006/table">
            <a:tbl>
              <a:tblPr/>
              <a:tblGrid>
                <a:gridCol w="155841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49045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57582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Name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Sequence (5'-3')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Description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aggs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-TNF-F</a:t>
                      </a:r>
                    </a:p>
                  </a:txBody>
                  <a:tcPr marL="3405" marR="3405" marT="340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ATGACGACGATAAGCTCAGATCATCGTCTCAAACCTCAG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TNF-α overexpression plasmid construction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aggs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-TNF-R</a:t>
                      </a:r>
                    </a:p>
                  </a:txBody>
                  <a:tcPr marL="3405" marR="3405" marT="340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TTAAGATCTGCTAGTCACAGGGCAATGATCCCAAAAT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aggs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-pig-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Rnase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 L-F</a:t>
                      </a:r>
                    </a:p>
                  </a:txBody>
                  <a:tcPr marL="3405" marR="3405" marT="340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ATGACGACGATAAGATGGAGACCAAGCGCCATAAC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4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RNase L overexpression plasmid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s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 construction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aggs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-pig-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Rnase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 L-R</a:t>
                      </a:r>
                    </a:p>
                  </a:txBody>
                  <a:tcPr marL="3405" marR="3405" marT="340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TTAAGATCTGCTAGTTACTAGGTCTGGCCATCACCAGC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aggs-human-Rnase L-F</a:t>
                      </a:r>
                    </a:p>
                  </a:txBody>
                  <a:tcPr marL="3405" marR="3405" marT="340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ATGACGACGATAAGATGGAGAGCAGGGATCATAACAACC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aggs-human-Rnase L-R</a:t>
                      </a:r>
                    </a:p>
                  </a:txBody>
                  <a:tcPr marL="3405" marR="3405" marT="340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TTAAGATCTGCTAGTCAGCACCCAGGGCTGGC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GL3-GLIS3-pro-F</a:t>
                      </a:r>
                    </a:p>
                  </a:txBody>
                  <a:tcPr marL="3405" marR="3405" marT="340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CCAGAACATTTCTCTATCGATAGTACTTGAGGGCTTTTATCTTGATC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GLIS3 promoter reporter plasmid construction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GL3-GLIS3-pro-R</a:t>
                      </a:r>
                    </a:p>
                  </a:txBody>
                  <a:tcPr marL="3405" marR="3405" marT="340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AGCACGCGTAAGAGCTCGGTAACCGGGATTTCCACAA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-circGLIS3-flanking-F</a:t>
                      </a:r>
                    </a:p>
                  </a:txBody>
                  <a:tcPr marL="3405" marR="3405" marT="340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TTGGTACCGAGCTCGGATGACCCTTTGATTTTGAGCA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pc-circGLIS3-flanking plasmid construction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-circGLIS3-flanking-R</a:t>
                      </a:r>
                    </a:p>
                  </a:txBody>
                  <a:tcPr marL="3405" marR="3405" marT="340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GCTGGATATCTGCAACTTGCCTTACAATTATCACCTGTTTGG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-circTNFAIP3-flanking-up-F</a:t>
                      </a:r>
                    </a:p>
                  </a:txBody>
                  <a:tcPr marL="3405" marR="3405" marT="340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TTGGTACCGAGCTCACAGCGTGTTATGTCTTGCCTCTGT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6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pc-circTNFAIP3-flanking overexpression plasmid construction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-circTNFAIP3-flanking-up-R</a:t>
                      </a:r>
                    </a:p>
                  </a:txBody>
                  <a:tcPr marL="3405" marR="3405" marT="340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TGGAACAGCAGCCAGAAAGGAAG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-circTNFAIP3-flanking-middle-F</a:t>
                      </a:r>
                    </a:p>
                  </a:txBody>
                  <a:tcPr marL="3405" marR="3405" marT="340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TTCTGGCTGCTGTTCCAGGCCTTGTAGAGCACCATGGCTGAGC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-circTNFAIP3-flanking-middle-R</a:t>
                      </a:r>
                    </a:p>
                  </a:txBody>
                  <a:tcPr marL="3405" marR="3405" marT="340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ATTCGTTTTCAGTGCCACAAGCTT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-circTNFAIP3-flanking-down-F</a:t>
                      </a:r>
                    </a:p>
                  </a:txBody>
                  <a:tcPr marL="3405" marR="3405" marT="340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GCACTGAAAACGAATGGTGAGTCTCCTAAAGCCCATG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-circTNFAIP3-flanking-down-R</a:t>
                      </a:r>
                    </a:p>
                  </a:txBody>
                  <a:tcPr marL="3405" marR="3405" marT="340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GCTGGATATCTGCAACTTGCCTTACAATTATCACCTGTT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-circGLIS3-mini-up-F</a:t>
                      </a:r>
                    </a:p>
                  </a:txBody>
                  <a:tcPr marL="3405" marR="3405" marT="340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buNone/>
                      </a:pPr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TTGGTACCGAGCTCGAATGAGTGTTTTGTTTGTGGCTC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6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pc-circGLIS3-mini minigene plasmid construction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-circGLIS3-mini-up-R</a:t>
                      </a:r>
                    </a:p>
                  </a:txBody>
                  <a:tcPr marL="3405" marR="3405" marT="340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ATGATGTTATGGCACACAGAGTTT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-circGLIS3-mini-middle-F</a:t>
                      </a:r>
                    </a:p>
                  </a:txBody>
                  <a:tcPr marL="3405" marR="3405" marT="340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TTGGTACCGAGCTCGCCTGGGAACTTCCATATGCTACA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-circGLIS3-mini-middle-R</a:t>
                      </a:r>
                    </a:p>
                  </a:txBody>
                  <a:tcPr marL="3405" marR="3405" marT="340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ATGATGTTATGGCACACAGAGTTT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-circGLIS3-mini-down-F</a:t>
                      </a:r>
                    </a:p>
                  </a:txBody>
                  <a:tcPr marL="3405" marR="3405" marT="340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AGGTGATAATTGTAAGGCAAGGATCATAATGATTCAGCAGACACATG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-circGLIS3-mini-down-R</a:t>
                      </a:r>
                    </a:p>
                  </a:txBody>
                  <a:tcPr marL="3405" marR="3405" marT="340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GCTGGATATCTGCATGGTATATGACAGCTCCTAAAATGC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GL3-CMV-pro-F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buNone/>
                      </a:pPr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CCAGAACATTTCTCTATCGATA</a:t>
                      </a:r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GTGATGCGGTTTTGGCAG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CMV promoter reporter plasmid construction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GL3-CMV-pro-R</a:t>
                      </a:r>
                    </a:p>
                  </a:txBody>
                  <a:tcPr marL="3405" marR="3405" marT="340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AGCACGCGTAAGAGCTC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CCTATAGTGAGTCGTATTAATTTCGA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aggs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-TGEV-N-F</a:t>
                      </a:r>
                    </a:p>
                  </a:txBody>
                  <a:tcPr marL="3405" marR="3405" marT="340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ATGACGACGATAAGATGGCCAACCAGGGACAAC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8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oV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 N protein overexpression plasmids construction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aggs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-TGEV-N-F</a:t>
                      </a:r>
                    </a:p>
                  </a:txBody>
                  <a:tcPr marL="3405" marR="3405" marT="340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TTAAGATCTGCTAGTTAGTTCGTTACCTCATCAATCATCTC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aggs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-PEDV-N-F</a:t>
                      </a:r>
                    </a:p>
                  </a:txBody>
                  <a:tcPr marL="3405" marR="3405" marT="340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ATGACGACGATAAGATGGCTTCTGTCAGCTTCCAGGATC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aggs-PEDV-N-F</a:t>
                      </a:r>
                    </a:p>
                  </a:txBody>
                  <a:tcPr marL="3405" marR="3405" marT="340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TTAAGATCTGCTAGTTAATTTCCTGTGTCGAAGATCTCGTTG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aggs-IBV-N-F</a:t>
                      </a:r>
                    </a:p>
                  </a:txBody>
                  <a:tcPr marL="3405" marR="3405" marT="340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ATGACGACGATAAGATGGCAAGCGGTAAGGCAACT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aggs-IBV-N-F</a:t>
                      </a:r>
                    </a:p>
                  </a:txBody>
                  <a:tcPr marL="3405" marR="3405" marT="340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TTAAGATCTGCTAGTCAAAGTTCATTCTCTCCTAGGGCT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aggs-SARS-CoV-N-F</a:t>
                      </a:r>
                    </a:p>
                  </a:txBody>
                  <a:tcPr marL="3405" marR="3405" marT="340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ATGACGACGATAAGATGTCTGATAATGGACCCCAAAAT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aggs-SARS-CoV-N-F</a:t>
                      </a:r>
                    </a:p>
                  </a:txBody>
                  <a:tcPr marL="3405" marR="3405" marT="340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TTAAGATCTGCTAGTTAGGCCTGAGTTGAGTCAGCAC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-10-F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ATGACGACGATAAGGCGTCTTGGTTTCAGGTGCTCA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4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PDCoV N protein truncations constr</a:t>
                      </a:r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uc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ion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3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-10-R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TTAAGATCTGCTAGCTACGCTGCTGATTCCTGCTTTATC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-142-F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ATGACGACGATAAGTTCAACGCTAGAGGAAGACCTCAG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-176-F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ATGACGACGATAAGGCACCAGCTGCGGTACGTC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94-343-F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ATGACGACGATAAGATGGCTGCACCAGTAGTCCCTACTA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94-343-R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TTAAGATCTGCTAGCCTAGGTAGGTGGCTCATAGGTCTGGTTA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77-343-R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TTAAGATCTGCTAGCTAAGATTGGTCGCGTTTCCTGGG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43-343-R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TTAAGATCTGCTAGCTAGGGGTCAACTCTGAAACCTTGAG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4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43-176-up-F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ATGACGACGATAAGATGGCTGCACCAGTAGTCCCTACTA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4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43-176-up-R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GGGTCAACTCTGAAACCTTGAG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4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43-176-down-F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TTCAGAGTTGACCCCGCACCAGCTGCGGTACGTC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4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43-176-down-R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TTAAGATCTGCTAGCTACGCTGCTGATTCCTGCTTTATC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4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43-153-up-F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ATGACGACGATAAGATGGCTGCACCAGTAGTCCCTACTA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4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43-153-up-R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GGGTCAACTCTGAAACCTTGAG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4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43-153-down-F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TTCAGAGTTGACCCCAGTGGCCCAAGATCTCAATCTGTTA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4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43-153-down-R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TTAAGATCTGCTAGCTACGCTGCTGATTCCTGCTTTATC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4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54-165-up-F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ATGACGACGATAAGATGGCTGCACCAGTAGTCCCTACTA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4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54-165-up-R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CCACGCTCCTGAGGTCTTCCTCTA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5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54-165-down-F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AGACCTCAGGAGCGTGGAACAGGCAATCAGCCCAGGAAAC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5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54-165-down-R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TTAAGATCTGCTAGCTACGCTGCTGATTCCTGCTTTATC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5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66-176-up-F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ATGACGACGATAAGATGGCTGCACCAGTAGTCCCTACTA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5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66-176-up-R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CCTCTGGAGTTAACAGATTGAGAT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5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66-176-down-F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ATCTGTTAACTCCAGAGGCGCACCAGCTGCGGTACGTC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5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66-176-down-R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TTAAGATCTGCTAGCTACGCTGCTGATTCCTGCTTTATC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5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5-UTR-F-GLO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AAACGAGCTCGCTAGCCCAGAGTGAGGACACCAGGGGA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5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5-UTR-R-GLO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AGGTCGACTCTAGAGGTGTCTTTTTCAGAGGGGCTCA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5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DS-F-GLO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AAACGAGCTCGCTAGCATGAGCACTGAGAGCATGATCCGAG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 </a:t>
                      </a:r>
                      <a:r>
                        <a:rPr lang="en-US" altLang="zh-CN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NF-α</a:t>
                      </a:r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 mRNA luciferase reporter plasmid construction</a:t>
                      </a: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5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DS-R-GLO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AGGTCGACTCTAGATCACAGGGCAATGATCCCAAAATAG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6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3-UTR-F-GLO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AAACGAGCTCGCTAGCGGGGGCAGGACATCCGTTC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6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3-UTR-R-GLO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AGGTCGACTCTAGATTTCTGTTTGTTTTTTAGGGCCAAA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6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aggs-METTL3-F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ATGACGACGATAAGATGTCGGACACGTGGAGCTCTAT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6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aggs-METTL3-R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TTAAGATCTGCTAGCTATAAATTCTTAGGTTTAGAGATGATACC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6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aggs-METTL14-F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ATGACGACGATAAGATGGACAGCCGCTTGCAGGAGA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</a:t>
                      </a:r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or porcine methyltransferase overexpression plasmids constructio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65"/>
                  </a:ext>
                </a:extLst>
              </a:tr>
              <a:tr h="131185"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aggs-METTL14-R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TTAAGATCTGCTAGCTATCGAGGTGGAAAGCCACCTCTG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6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altLang="zh-CN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aggs</a:t>
                      </a:r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-WTAP-F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ATGACGACGATAAGATGACCAACGAGGAACCTCTTCC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6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caggs</a:t>
                      </a:r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-WTAP-R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TTAAGATCTGCTAGTTACAAAACCGAACCCTGTACATTT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68"/>
                  </a:ext>
                </a:extLst>
              </a:tr>
              <a:tr h="0">
                <a:tc gridSpan="3"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bbreviations:  F, Forward; R, Reverse.</a:t>
                      </a:r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 marL="3405" marR="3405" marT="34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 marL="3405" marR="3405" marT="34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69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内容占位符 2"/>
          <p:cNvSpPr>
            <a:spLocks noGrp="1"/>
          </p:cNvSpPr>
          <p:nvPr>
            <p:ph idx="1"/>
          </p:nvPr>
        </p:nvSpPr>
        <p:spPr>
          <a:xfrm>
            <a:off x="970696" y="1532553"/>
            <a:ext cx="4916601" cy="360560"/>
          </a:xfrm>
        </p:spPr>
        <p:txBody>
          <a:bodyPr>
            <a:normAutofit/>
          </a:bodyPr>
          <a:lstStyle/>
          <a:p>
            <a:pPr marL="0" indent="0" algn="ctr" defTabSz="685800">
              <a:lnSpc>
                <a:spcPct val="100000"/>
              </a:lnSpc>
              <a:buNone/>
            </a:pPr>
            <a:r>
              <a:rPr lang="en-US" altLang="zh-CN" sz="1200" b="1" dirty="0">
                <a:solidFill>
                  <a:schemeClr val="tx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3 RNA sequences</a:t>
            </a:r>
            <a:endParaRPr lang="zh-CN" altLang="en-US" sz="1200" b="1" dirty="0">
              <a:solidFill>
                <a:schemeClr val="tx2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表格 2"/>
          <p:cNvGraphicFramePr>
            <a:graphicFrameLocks noGrp="1"/>
          </p:cNvGraphicFramePr>
          <p:nvPr/>
        </p:nvGraphicFramePr>
        <p:xfrm>
          <a:off x="344485" y="2040762"/>
          <a:ext cx="6169025" cy="2435365"/>
        </p:xfrm>
        <a:graphic>
          <a:graphicData uri="http://schemas.openxmlformats.org/drawingml/2006/table">
            <a:tbl>
              <a:tblPr/>
              <a:tblGrid>
                <a:gridCol w="94973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83492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70734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67701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133477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Name</a:t>
                      </a:r>
                    </a:p>
                  </a:txBody>
                  <a:tcPr marL="5134" marR="5134" marT="513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1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ense (5' to 3')</a:t>
                      </a:r>
                    </a:p>
                  </a:txBody>
                  <a:tcPr marL="5134" marR="5134" marT="513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altLang="zh-CN" sz="800" b="1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ntisense (5' to 3')</a:t>
                      </a:r>
                      <a:endParaRPr lang="zh-CN" altLang="en-US" sz="800" b="1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34" marR="5134" marT="513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escription</a:t>
                      </a:r>
                    </a:p>
                  </a:txBody>
                  <a:tcPr marL="5134" marR="5134" marT="513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18076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sc-miR-125b</a:t>
                      </a:r>
                    </a:p>
                  </a:txBody>
                  <a:tcPr marL="5134" marR="5134" marT="513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UCCCUGAGACCCUAACUUGUGA</a:t>
                      </a:r>
                    </a:p>
                  </a:txBody>
                  <a:tcPr marL="5134" marR="5134" marT="513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34" marR="5134" marT="513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12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miRNA mimics</a:t>
                      </a:r>
                    </a:p>
                  </a:txBody>
                  <a:tcPr marL="5134" marR="5134" marT="513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18076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sc-miR-30c-1-3p</a:t>
                      </a:r>
                    </a:p>
                  </a:txBody>
                  <a:tcPr marL="5134" marR="5134" marT="51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UGGGAGAGGGUUGUUUACU</a:t>
                      </a:r>
                    </a:p>
                  </a:txBody>
                  <a:tcPr marL="5134" marR="5134" marT="51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34" marR="5134" marT="513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18076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sc-miR-30c-3p</a:t>
                      </a:r>
                    </a:p>
                  </a:txBody>
                  <a:tcPr marL="5134" marR="5134" marT="51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UGGGAGAAGGCUGUUUACUCU</a:t>
                      </a:r>
                    </a:p>
                  </a:txBody>
                  <a:tcPr marL="5134" marR="5134" marT="51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34" marR="5134" marT="513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18076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sc-miR-671-5p</a:t>
                      </a:r>
                    </a:p>
                  </a:txBody>
                  <a:tcPr marL="5134" marR="5134" marT="51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GGAAGCCCUGGAGGGGCUGGAGG</a:t>
                      </a:r>
                    </a:p>
                  </a:txBody>
                  <a:tcPr marL="5134" marR="5134" marT="51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34" marR="5134" marT="513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18076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novel_181</a:t>
                      </a:r>
                    </a:p>
                  </a:txBody>
                  <a:tcPr marL="5134" marR="5134" marT="51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UGCUGGAGGACGCCCGGUGU</a:t>
                      </a:r>
                    </a:p>
                  </a:txBody>
                  <a:tcPr marL="5134" marR="5134" marT="51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34" marR="5134" marT="513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18076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novel_878</a:t>
                      </a:r>
                    </a:p>
                  </a:txBody>
                  <a:tcPr marL="5134" marR="5134" marT="51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UCACCCGCACCCUUCCACCCCAGG</a:t>
                      </a:r>
                    </a:p>
                  </a:txBody>
                  <a:tcPr marL="5134" marR="5134" marT="51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34" marR="5134" marT="513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18076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novel_332</a:t>
                      </a:r>
                    </a:p>
                  </a:txBody>
                  <a:tcPr marL="5134" marR="5134" marT="51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UGCGGGGAGCCGAGGCGACCAGC</a:t>
                      </a:r>
                    </a:p>
                  </a:txBody>
                  <a:tcPr marL="5134" marR="5134" marT="51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34" marR="5134" marT="513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18076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novel_368</a:t>
                      </a:r>
                    </a:p>
                  </a:txBody>
                  <a:tcPr marL="5134" marR="5134" marT="51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CCAUCUUCCCUCCGUCCCUGCC</a:t>
                      </a:r>
                    </a:p>
                  </a:txBody>
                  <a:tcPr marL="5134" marR="5134" marT="51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34" marR="5134" marT="513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18076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novel_431</a:t>
                      </a:r>
                    </a:p>
                  </a:txBody>
                  <a:tcPr marL="5134" marR="5134" marT="51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GGGCUGGUCCGGGACGUCUGGUCC</a:t>
                      </a:r>
                    </a:p>
                  </a:txBody>
                  <a:tcPr marL="5134" marR="5134" marT="51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34" marR="5134" marT="513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18076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novel_459</a:t>
                      </a:r>
                    </a:p>
                  </a:txBody>
                  <a:tcPr marL="5134" marR="5134" marT="51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GCUGGGCUGCUGUUCUCGAGGU</a:t>
                      </a:r>
                    </a:p>
                  </a:txBody>
                  <a:tcPr marL="5134" marR="5134" marT="51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34" marR="5134" marT="513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18076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novel_547</a:t>
                      </a:r>
                    </a:p>
                  </a:txBody>
                  <a:tcPr marL="5134" marR="5134" marT="51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UCCUCCCCUUCUGCUGUACUGGGU</a:t>
                      </a:r>
                    </a:p>
                  </a:txBody>
                  <a:tcPr marL="5134" marR="5134" marT="51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34" marR="5134" marT="513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18076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novel_578</a:t>
                      </a:r>
                    </a:p>
                  </a:txBody>
                  <a:tcPr marL="5134" marR="5134" marT="51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UUGGCUGGUCUCUUCCCUGCAGU</a:t>
                      </a:r>
                    </a:p>
                  </a:txBody>
                  <a:tcPr marL="5134" marR="5134" marT="51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34" marR="5134" marT="513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1807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i-circGLIS3-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UAAGUGUUCGGUCCCUUAT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UAAGGGACCGAACACUUAUTT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3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For porcine circGLIS3 knockdown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1807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i-circGLIS3-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GUGUUCGGUCCCUUAUUUT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AAUAAGGGACCGAACACUTT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1807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i-circGLIS3-3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UAAGUGUUCGGUCCCUUAUT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UAAGGGACCGAACACUUATT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1807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i-IGF2BP2-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CUGGCUGUUAAUCAACAAT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UUGUUGAUUAACAGCCAGCT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3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For porcine IGF2BP2 knockdown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1807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i-IGF2BP2-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CCUCAUCAUCACUCUUAUT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UAAGAGUGAUGAUGAGGGT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1807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i-IGF2BP2-3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UCGCAUCUUUGGGAAACUT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GUUUCCCAAAGAUGCGACT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rgbClr val="000000"/>
      </a:dk1>
      <a:lt1>
        <a:srgbClr val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134</Words>
  <Application>Microsoft Office PowerPoint</Application>
  <PresentationFormat>自定义</PresentationFormat>
  <Paragraphs>691</Paragraphs>
  <Slides>6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3" baseType="lpstr">
      <vt:lpstr>等线</vt:lpstr>
      <vt:lpstr>宋体</vt:lpstr>
      <vt:lpstr>Arial</vt:lpstr>
      <vt:lpstr>Calibri</vt:lpstr>
      <vt:lpstr>Times New Roman</vt:lpstr>
      <vt:lpstr>Wingdings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>Administrator</dc:creator>
  <cp:lastModifiedBy>柳阳 杜</cp:lastModifiedBy>
  <cp:revision>1063</cp:revision>
  <dcterms:created xsi:type="dcterms:W3CDTF">2019-06-19T02:08:00Z</dcterms:created>
  <dcterms:modified xsi:type="dcterms:W3CDTF">2026-06-19T15:25:3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5865</vt:lpwstr>
  </property>
  <property fmtid="{D5CDD505-2E9C-101B-9397-08002B2CF9AE}" pid="3" name="ICV">
    <vt:lpwstr>4BCDA39FD16A4FB7A46BF1AEBA7AD4BF_13</vt:lpwstr>
  </property>
</Properties>
</file>